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96088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1DBB53-75E6-4711-8568-2CC655019E6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2F2BF4-E567-41ED-B6C2-72AC6D59CD4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2269DA-52B0-44F3-9754-BD38058AA43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CEF837-4C32-4E33-84D3-1591281D466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726BCB-D523-4638-8A06-6AE35E0331E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56DD2D-91A8-4468-B285-57371489246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1EF4EE-0594-419D-B565-742204F1315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0B3F8B-BDF0-4F3E-BE8F-65F58825E3A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24355B-E21A-4086-8E7A-0376B84F89B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B7EB1A-AE5E-490B-9756-F087FE33572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48150C-3FB6-442E-8665-871B8885772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AE13C7-EACC-4B71-A44D-C93888DC90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400" spc="-1" strike="noStrike">
                <a:solidFill>
                  <a:srgbClr val="000000"/>
                </a:solidFill>
                <a:latin typeface="Arial"/>
                <a:ea typeface="新細明體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400" spc="-1" strike="noStrike">
                <a:solidFill>
                  <a:srgbClr val="000000"/>
                </a:solidFill>
                <a:latin typeface="Arial"/>
                <a:ea typeface="新細明體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400" spc="-1" strike="noStrike">
                <a:solidFill>
                  <a:srgbClr val="000000"/>
                </a:solidFill>
                <a:latin typeface="Arial"/>
                <a:ea typeface="新細明體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400" spc="-1" strike="noStrike">
                <a:solidFill>
                  <a:srgbClr val="000000"/>
                </a:solidFill>
                <a:latin typeface="Arial"/>
                <a:ea typeface="新細明體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400" spc="-1" strike="noStrike">
                <a:solidFill>
                  <a:srgbClr val="000000"/>
                </a:solidFill>
                <a:latin typeface="Arial"/>
                <a:ea typeface="新細明體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50D19ED-9D7F-4934-A432-8B043755DD4B}" type="slidenum">
              <a:rPr b="0" lang="zh-TW" sz="1400" spc="-1" strike="noStrike">
                <a:solidFill>
                  <a:srgbClr val="000000"/>
                </a:solidFill>
                <a:latin typeface="Arial"/>
                <a:ea typeface="新細明體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479600" y="5754600"/>
          <a:ext cx="4248000" cy="3121200"/>
        </p:xfrm>
        <a:graphic>
          <a:graphicData uri="http://schemas.openxmlformats.org/drawingml/2006/table">
            <a:tbl>
              <a:tblPr/>
              <a:tblGrid>
                <a:gridCol w="411120"/>
                <a:gridCol w="669960"/>
                <a:gridCol w="3166920"/>
              </a:tblGrid>
              <a:tr h="3348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Slic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Coverage (100%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Protein Descriptio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456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1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Heat shock 70kDa protein 5; BiP 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420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5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RuvB-like 2; TBP-interacting protein, 48-KD; Reptin5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420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33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nb-NO" sz="8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TATA binding protein interacting protein 49 kDa; RuvB-like 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456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36.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GrpE-like 1, mitochondrial; GrpE-like protein cochaperone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420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16.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SKB1 homolog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420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13.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Heat shock 70kD protein 9; stress-70 protein,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456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5.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MEP50 protei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420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19.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Nucleophosmin 1; nucleolar phosphoprotein B23; numatrin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420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4.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EBNA-2 co-activator (100kD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456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19.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Heat shock 70kDa protein 5; BiP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420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25.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poly(A) binding protein, cytoplasmic 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420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9.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Ras-GTPase activating protein SH3 domain-binding protein 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456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27.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2,4-dienoyl CoA reductase 1 precursor; 4-enoyl-CoA reductas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42" name=""/>
          <p:cNvGraphicFramePr/>
          <p:nvPr/>
        </p:nvGraphicFramePr>
        <p:xfrm>
          <a:off x="1495440" y="1393920"/>
          <a:ext cx="1838160" cy="36097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3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495440" y="1393920"/>
                    <a:ext cx="1838160" cy="36097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4" name=""/>
          <p:cNvSpPr/>
          <p:nvPr/>
        </p:nvSpPr>
        <p:spPr>
          <a:xfrm>
            <a:off x="2709720" y="2978280"/>
            <a:ext cx="284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800" spc="-1" strike="noStrike">
                <a:solidFill>
                  <a:srgbClr val="000000"/>
                </a:solidFill>
                <a:latin typeface="Arial"/>
                <a:ea typeface="新細明體"/>
              </a:rPr>
              <a:t>►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 flipH="1">
            <a:off x="1355040" y="1228680"/>
            <a:ext cx="601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SimSun"/>
              </a:rPr>
              <a:t>Marker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1758960" y="1200240"/>
            <a:ext cx="407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新細明體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2028960" y="1200240"/>
            <a:ext cx="315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新細明體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2282760" y="1200240"/>
            <a:ext cx="284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新細明體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2538360" y="1209600"/>
            <a:ext cx="258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新細明體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2797200" y="1209600"/>
            <a:ext cx="306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新細明體"/>
              </a:rPr>
              <a:t>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3051000" y="1209600"/>
            <a:ext cx="39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新細明體"/>
              </a:rPr>
              <a:t>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2435400" y="2075040"/>
            <a:ext cx="284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800" spc="-1" strike="noStrike">
                <a:solidFill>
                  <a:srgbClr val="000000"/>
                </a:solidFill>
                <a:latin typeface="Arial"/>
                <a:ea typeface="新細明體"/>
              </a:rPr>
              <a:t>►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2438280" y="2386080"/>
            <a:ext cx="284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800" spc="-1" strike="noStrike">
                <a:solidFill>
                  <a:srgbClr val="000000"/>
                </a:solidFill>
                <a:latin typeface="Arial"/>
                <a:ea typeface="新細明體"/>
              </a:rPr>
              <a:t>►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2451240" y="3238560"/>
            <a:ext cx="284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800" spc="-1" strike="noStrike">
                <a:solidFill>
                  <a:srgbClr val="000000"/>
                </a:solidFill>
                <a:latin typeface="Arial"/>
                <a:ea typeface="新細明體"/>
              </a:rPr>
              <a:t>►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2705040" y="2759040"/>
            <a:ext cx="284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800" spc="-1" strike="noStrike">
                <a:solidFill>
                  <a:srgbClr val="000000"/>
                </a:solidFill>
                <a:latin typeface="Arial"/>
                <a:ea typeface="新細明體"/>
              </a:rPr>
              <a:t>►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2714760" y="2112840"/>
            <a:ext cx="284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800" spc="-1" strike="noStrike">
                <a:solidFill>
                  <a:srgbClr val="000000"/>
                </a:solidFill>
                <a:latin typeface="Arial"/>
                <a:ea typeface="新細明體"/>
              </a:rPr>
              <a:t>►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2968560" y="2300400"/>
            <a:ext cx="284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800" spc="-1" strike="noStrike">
                <a:solidFill>
                  <a:srgbClr val="000000"/>
                </a:solidFill>
                <a:latin typeface="Arial"/>
                <a:ea typeface="新細明體"/>
              </a:rPr>
              <a:t>►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2970360" y="2538360"/>
            <a:ext cx="284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800" spc="-1" strike="noStrike">
                <a:solidFill>
                  <a:srgbClr val="000000"/>
                </a:solidFill>
                <a:latin typeface="Arial"/>
                <a:ea typeface="新細明體"/>
              </a:rPr>
              <a:t>►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2978280" y="3024360"/>
            <a:ext cx="284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800" spc="-1" strike="noStrike">
                <a:solidFill>
                  <a:srgbClr val="000000"/>
                </a:solidFill>
                <a:latin typeface="Arial"/>
                <a:ea typeface="新細明體"/>
              </a:rPr>
              <a:t>►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 flipH="1">
            <a:off x="2382120" y="2070000"/>
            <a:ext cx="227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新細明體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 flipH="1">
            <a:off x="2386080" y="2390760"/>
            <a:ext cx="2268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新細明體"/>
              </a:rPr>
              <a:t>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 flipH="1">
            <a:off x="2397240" y="3236760"/>
            <a:ext cx="2268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新細明體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 flipH="1">
            <a:off x="2650320" y="2109960"/>
            <a:ext cx="2271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新細明體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 flipH="1">
            <a:off x="2637720" y="2754360"/>
            <a:ext cx="2271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新細明體"/>
              </a:rPr>
              <a:t>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 flipH="1">
            <a:off x="2649600" y="2979720"/>
            <a:ext cx="2268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新細明體"/>
              </a:rPr>
              <a:t>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 flipH="1">
            <a:off x="2921760" y="2303640"/>
            <a:ext cx="2271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新細明體"/>
              </a:rPr>
              <a:t>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2962440" y="2063880"/>
            <a:ext cx="284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800" spc="-1" strike="noStrike">
                <a:solidFill>
                  <a:srgbClr val="000000"/>
                </a:solidFill>
                <a:latin typeface="Arial"/>
                <a:ea typeface="新細明體"/>
              </a:rPr>
              <a:t>►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 flipH="1">
            <a:off x="2905920" y="2057400"/>
            <a:ext cx="2271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新細明體"/>
              </a:rPr>
              <a:t>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 flipH="1">
            <a:off x="2917800" y="2533680"/>
            <a:ext cx="3016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新細明體"/>
              </a:rPr>
              <a:t>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 flipH="1">
            <a:off x="2878200" y="3027240"/>
            <a:ext cx="3016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新細明體"/>
              </a:rPr>
              <a:t>1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1080" y="0"/>
            <a:ext cx="1223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新細明體"/>
              </a:rPr>
              <a:t>Figure S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915840" y="77940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新細明體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917640" y="529272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新細明體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8"/>
          <p:cNvSpPr/>
          <p:nvPr/>
        </p:nvSpPr>
        <p:spPr>
          <a:xfrm>
            <a:off x="1087560" y="826920"/>
            <a:ext cx="1549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1200" spc="-1" strike="noStrike">
                <a:solidFill>
                  <a:srgbClr val="000000"/>
                </a:solidFill>
                <a:latin typeface="Arial"/>
                <a:ea typeface="新細明體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新細明體"/>
              </a:rPr>
              <a:t>IB4 cel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00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4-23T07:43:06Z</dcterms:created>
  <dc:creator>User</dc:creator>
  <dc:description/>
  <dc:language>en-US</dc:language>
  <cp:lastModifiedBy>MC SYSTEM</cp:lastModifiedBy>
  <dcterms:modified xsi:type="dcterms:W3CDTF">2012-09-11T12:19:32Z</dcterms:modified>
  <cp:revision>1642</cp:revision>
  <dc:subject/>
  <dc:title>投影片 1</dc:title>
</cp:coreProperties>
</file>